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7772400" cy="100584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4D4D4"/>
    <a:srgbClr val="F0F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83" autoAdjust="0"/>
    <p:restoredTop sz="93333" autoAdjust="0"/>
  </p:normalViewPr>
  <p:slideViewPr>
    <p:cSldViewPr snapToGrid="0">
      <p:cViewPr varScale="1">
        <p:scale>
          <a:sx n="81" d="100"/>
          <a:sy n="81" d="100"/>
        </p:scale>
        <p:origin x="3488" y="19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8100" cy="3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53" tIns="48327" rIns="96653" bIns="48327" rtlCol="0"/>
          <a:lstStyle>
            <a:lvl1pPr algn="r">
              <a:defRPr sz="1200"/>
            </a:lvl1pPr>
          </a:lstStyle>
          <a:p>
            <a:fld id="{DFF2F5C7-A4CF-41FC-B581-A19316B58C59}" type="datetimeFigureOut">
              <a:rPr lang="en-US" smtClean="0"/>
              <a:t>3/19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200150"/>
            <a:ext cx="25050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3" tIns="48327" rIns="96653" bIns="4832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53" tIns="48327" rIns="96653" bIns="48327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5"/>
            <a:ext cx="3169920" cy="481726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5"/>
            <a:ext cx="3169920" cy="481726"/>
          </a:xfrm>
          <a:prstGeom prst="rect">
            <a:avLst/>
          </a:prstGeom>
        </p:spPr>
        <p:txBody>
          <a:bodyPr vert="horz" lIns="96653" tIns="48327" rIns="96653" bIns="48327" rtlCol="0" anchor="b"/>
          <a:lstStyle>
            <a:lvl1pPr algn="r">
              <a:defRPr sz="1200"/>
            </a:lvl1pPr>
          </a:lstStyle>
          <a:p>
            <a:fld id="{2D5D5237-F288-417B-9245-448A7B6213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253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D7B76F-3729-8F16-7A7F-752DE80024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71550" y="1646133"/>
            <a:ext cx="5829300" cy="3501813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528C1C-84B0-BE87-369E-31B09563A9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52DF6-51A2-FE02-61E7-451B52318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23BEE2-3CD6-E52D-0C4D-B43DEC541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A518BB-736D-A3EC-55FC-0E75EFAC0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10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0CFA35-E445-F1A3-4FAB-4971249AD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34977D-50C8-564E-459F-3A5DF90ECE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A9375A-CF91-89B5-0D95-12F483677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9F453E-EA92-C853-6544-09048AC495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9C5910-B47F-2542-0773-E61E51A63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755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4C9B783-F5A2-3B05-E4AD-7A64E313AE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835FD1-A47C-3ACA-01FF-CE2D803FDC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4CADE-A336-570E-D29F-A4BBC9C3B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D654B2-BB5C-64B2-292C-EF99C9753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5D4131-18F0-99F1-45C5-B2287A0E2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4088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DC1A0-53CD-E74C-B4C4-B01CD67EF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9027A-5E9F-B6ED-8E93-B1A177583C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9DF56B-72E3-52EE-7098-5C111112F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1704A3-39A5-A6EE-32FE-4E8DD9707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9D24D-B38D-B2B7-3CDC-CC56358D44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4921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46343C-987B-7F49-69DA-F52996A02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0304" y="2507617"/>
            <a:ext cx="6703695" cy="4184014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EB4EF5-6A8F-AA48-8F53-2F15D6EA2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0304" y="6731213"/>
            <a:ext cx="6703695" cy="2200274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82000"/>
                  </a:schemeClr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82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82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13CD6-81CC-06FC-369E-58FF1A3BC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778D4F-EF15-9748-5417-2AC8BD2DA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4CDED-FE31-9266-416A-338D40374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65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4EF438-3605-7E5D-FC41-E98EFB3793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5D6EA3-7EC5-FF60-6F60-3969FC1A32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769733-60C9-3C9B-1BE8-287BA32C7B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8F6185-9BC3-44EC-FA3F-B285B6E88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8B0228-5070-5378-2E61-A89985515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32102-0069-7C64-9B7B-C5550EE02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87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1B52BA-EDBC-AC4C-511E-FC54E3E5D5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535517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A0B05F-0AA4-B021-43E6-F18BF3251A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5365" y="2465706"/>
            <a:ext cx="3288089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97223E-3E47-97A9-9D72-32DD2F55FA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35365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5C9BDF-EF78-B08E-5836-DF99F6CA18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025DFB-352D-2299-4E5E-08205EBC34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35D379-AEFC-02C4-DDC7-71FF7AED8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80BE8C-1470-CF66-3889-47CE813D6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9CF6A4-F6A3-4C98-24B6-67582FDB4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035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77A051-A09B-6672-2C10-7317907549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A178E1-C213-70DD-578B-4E71BBF26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CF1EAB-944D-705D-A33A-05F7B6EE71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31F8BD-9FB5-0152-4D69-2D9E33593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145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220665-C962-99F0-1582-CE7E726C5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A2C6EE7-3286-B41A-83A5-4AF0D648D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AADDDA-3F5B-3CB0-66A3-18F665E977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375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2E294-A4E0-570F-C40F-AEBE8C6CE8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5DA1C5-24BF-8BA4-0222-7D1757759A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C4732A-F61E-9432-C04D-59795889EA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E9A823-C029-5715-5BA6-994493619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D37A63-5AB5-BE83-1345-9EDDA5680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6753E-EB40-2C72-C503-7BC7C6B02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772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0D6ED-6C55-8AD3-FF08-82E5E2589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7EE2CA-E723-DE20-DFEE-4494E252BFB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9C466C-EAC2-371C-F64C-B531BECA54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26A629-21CA-EC9B-096E-63220EF26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CD89DE-5EDB-A1CC-40E7-CAB0F3E15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E7E1B2-2081-8D71-C261-3A2BB4754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684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5E01FB-2518-5CF1-6C13-EF1E14C5F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353" y="535517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667CAF-17EE-0C4E-C915-905724F21A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CB5722-0865-A8BB-8043-4E1A830297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353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C22B50-26DF-416F-966B-A7F98F83DB9A}" type="datetimeFigureOut">
              <a:rPr lang="en-US" smtClean="0"/>
              <a:t>3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C54CE7-E3B2-19A8-E82C-9E54D5CE2D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608" y="9322647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F94F84-19C9-E960-5673-1B3459DA01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258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7A8D73-2CE0-4A7E-BFBE-2189AD6A76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724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82930" rtl="0" eaLnBrk="1" latinLnBrk="0" hangingPunct="1">
        <a:lnSpc>
          <a:spcPct val="90000"/>
        </a:lnSpc>
        <a:spcBef>
          <a:spcPct val="0"/>
        </a:spcBef>
        <a:buNone/>
        <a:defRPr sz="2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733" indent="-145733" algn="l" defTabSz="582930" rtl="0" eaLnBrk="1" latinLnBrk="0" hangingPunct="1">
        <a:lnSpc>
          <a:spcPct val="90000"/>
        </a:lnSpc>
        <a:spcBef>
          <a:spcPts val="638"/>
        </a:spcBef>
        <a:buFont typeface="Arial" panose="020B0604020202020204" pitchFamily="34" charset="0"/>
        <a:buChar char="•"/>
        <a:defRPr sz="1785" kern="1200">
          <a:solidFill>
            <a:schemeClr val="tx1"/>
          </a:solidFill>
          <a:latin typeface="+mn-lt"/>
          <a:ea typeface="+mn-ea"/>
          <a:cs typeface="+mn-cs"/>
        </a:defRPr>
      </a:lvl1pPr>
      <a:lvl2pPr marL="43719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2866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102012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31159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60305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89452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18598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47745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1pPr>
      <a:lvl2pPr marL="29146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2pPr>
      <a:lvl3pPr marL="58293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3pPr>
      <a:lvl4pPr marL="87439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16586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45732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74879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04025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9401D0A-80D1-143D-CF8D-D84E0963AD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520050"/>
              </p:ext>
            </p:extLst>
          </p:nvPr>
        </p:nvGraphicFramePr>
        <p:xfrm>
          <a:off x="398144" y="941190"/>
          <a:ext cx="6976111" cy="853440"/>
        </p:xfrm>
        <a:graphic>
          <a:graphicData uri="http://schemas.openxmlformats.org/drawingml/2006/table">
            <a:tbl>
              <a:tblPr firstRow="1" firstCol="1" bandRow="1"/>
              <a:tblGrid>
                <a:gridCol w="1661160">
                  <a:extLst>
                    <a:ext uri="{9D8B030D-6E8A-4147-A177-3AD203B41FA5}">
                      <a16:colId xmlns:a16="http://schemas.microsoft.com/office/drawing/2014/main" val="3852068263"/>
                    </a:ext>
                  </a:extLst>
                </a:gridCol>
                <a:gridCol w="715885">
                  <a:extLst>
                    <a:ext uri="{9D8B030D-6E8A-4147-A177-3AD203B41FA5}">
                      <a16:colId xmlns:a16="http://schemas.microsoft.com/office/drawing/2014/main" val="2646940788"/>
                    </a:ext>
                  </a:extLst>
                </a:gridCol>
                <a:gridCol w="1207901">
                  <a:extLst>
                    <a:ext uri="{9D8B030D-6E8A-4147-A177-3AD203B41FA5}">
                      <a16:colId xmlns:a16="http://schemas.microsoft.com/office/drawing/2014/main" val="1311677662"/>
                    </a:ext>
                  </a:extLst>
                </a:gridCol>
                <a:gridCol w="936607">
                  <a:extLst>
                    <a:ext uri="{9D8B030D-6E8A-4147-A177-3AD203B41FA5}">
                      <a16:colId xmlns:a16="http://schemas.microsoft.com/office/drawing/2014/main" val="4105727725"/>
                    </a:ext>
                  </a:extLst>
                </a:gridCol>
                <a:gridCol w="510290">
                  <a:extLst>
                    <a:ext uri="{9D8B030D-6E8A-4147-A177-3AD203B41FA5}">
                      <a16:colId xmlns:a16="http://schemas.microsoft.com/office/drawing/2014/main" val="2261829960"/>
                    </a:ext>
                  </a:extLst>
                </a:gridCol>
                <a:gridCol w="746350">
                  <a:extLst>
                    <a:ext uri="{9D8B030D-6E8A-4147-A177-3AD203B41FA5}">
                      <a16:colId xmlns:a16="http://schemas.microsoft.com/office/drawing/2014/main" val="287018792"/>
                    </a:ext>
                  </a:extLst>
                </a:gridCol>
                <a:gridCol w="625519">
                  <a:extLst>
                    <a:ext uri="{9D8B030D-6E8A-4147-A177-3AD203B41FA5}">
                      <a16:colId xmlns:a16="http://schemas.microsoft.com/office/drawing/2014/main" val="1601899866"/>
                    </a:ext>
                  </a:extLst>
                </a:gridCol>
                <a:gridCol w="572399">
                  <a:extLst>
                    <a:ext uri="{9D8B030D-6E8A-4147-A177-3AD203B41FA5}">
                      <a16:colId xmlns:a16="http://schemas.microsoft.com/office/drawing/2014/main" val="24067242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ubtype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ample Size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dian </a:t>
                      </a:r>
                      <a:r>
                        <a:rPr lang="en-US" sz="8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K2</a:t>
                      </a: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FAK)</a:t>
                      </a:r>
                      <a:r>
                        <a:rPr lang="en-US" sz="800" b="1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pression 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TPM)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dian TPM 95% CI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R* 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HR 95% CI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5829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dian diff 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8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os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)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108383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l melanomas-high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7.774 </a:t>
                      </a:r>
                      <a:endParaRPr lang="en-US" sz="8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2.999-354.909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95942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l melanomas-low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3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304</a:t>
                      </a:r>
                      <a:endParaRPr lang="en-US" sz="800" b="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.985-72.734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818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42-0.90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5829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3.357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&lt;0.0001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90990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RAF</a:t>
                      </a:r>
                      <a:r>
                        <a:rPr lang="en-US" sz="8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600E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(dab/Tram) </a:t>
                      </a:r>
                      <a:r>
                        <a:rPr lang="en-US" sz="800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K2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high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8.958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0.278-366.440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0645313"/>
                  </a:ext>
                </a:extLst>
              </a:tr>
              <a:tr h="6709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RAF</a:t>
                      </a:r>
                      <a:r>
                        <a:rPr lang="en-US" sz="8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600E 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dab/Tram) </a:t>
                      </a:r>
                      <a:r>
                        <a:rPr lang="en-US" sz="800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TK2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low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1.55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.248-78.04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46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36-0.95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5829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2.438</a:t>
                      </a:r>
                      <a:endParaRPr lang="en-US" sz="800" b="1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28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8EAADB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128887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7C96E42-0534-0130-E65E-B4B58F5DA645}"/>
              </a:ext>
            </a:extLst>
          </p:cNvPr>
          <p:cNvSpPr txBox="1"/>
          <p:nvPr/>
        </p:nvSpPr>
        <p:spPr>
          <a:xfrm>
            <a:off x="339476" y="473241"/>
            <a:ext cx="18181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3965867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043</TotalTime>
  <Words>77</Words>
  <Application>Microsoft Macintosh PowerPoint</Application>
  <PresentationFormat>Custom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>Huntsman Cancer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ly Stanley</dc:creator>
  <cp:lastModifiedBy>Karly Stanley</cp:lastModifiedBy>
  <cp:revision>115</cp:revision>
  <dcterms:created xsi:type="dcterms:W3CDTF">2025-08-13T21:00:19Z</dcterms:created>
  <dcterms:modified xsi:type="dcterms:W3CDTF">2026-03-20T01:30:50Z</dcterms:modified>
</cp:coreProperties>
</file>